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2" name="Google Shape;172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3360908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Google Shape;174;p20">
            <a:extLst>
              <a:ext uri="{FF2B5EF4-FFF2-40B4-BE49-F238E27FC236}">
                <a16:creationId xmlns:a16="http://schemas.microsoft.com/office/drawing/2014/main" id="{CC4FCD4A-746E-4E8B-B1AF-65C1AF316817}"/>
              </a:ext>
            </a:extLst>
          </p:cNvPr>
          <p:cNvSpPr txBox="1"/>
          <p:nvPr/>
        </p:nvSpPr>
        <p:spPr>
          <a:xfrm>
            <a:off x="384538" y="7070725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6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4 peptides with  wheat TaAMY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</a:t>
            </a:r>
            <a:r>
              <a:rPr lang="en-US" sz="1200" dirty="0"/>
              <a:t>1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unique peptides were recovered with 39% total coverage. 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7055F0D-4FA2-4867-9866-B4EFC4CAE3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127" y="872987"/>
            <a:ext cx="5499069" cy="610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7260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</TotalTime>
  <Words>70</Words>
  <Application>Microsoft Office PowerPoint</Application>
  <PresentationFormat>On-screen Show (4:3)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6:03Z</dcterms:modified>
</cp:coreProperties>
</file>